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42092"/>
    <a:srgbClr val="8A8CBD"/>
    <a:srgbClr val="30BF30"/>
    <a:srgbClr val="375EA6"/>
    <a:srgbClr val="7D40C1"/>
    <a:srgbClr val="D60004"/>
    <a:srgbClr val="797BA7"/>
    <a:srgbClr val="A0A1D4"/>
    <a:srgbClr val="40FF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37"/>
    <p:restoredTop sz="96190"/>
  </p:normalViewPr>
  <p:slideViewPr>
    <p:cSldViewPr snapToGrid="0">
      <p:cViewPr varScale="1">
        <p:scale>
          <a:sx n="123" d="100"/>
          <a:sy n="123" d="100"/>
        </p:scale>
        <p:origin x="11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8B25D6-CC5D-6943-B3E7-F72D2A915EAD}" type="datetimeFigureOut">
              <a:rPr lang="en-US" smtClean="0"/>
              <a:t>9/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4E7709-C06C-5C48-8206-42287D061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3234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74E7709-C06C-5C48-8206-42287D061BB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4698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EB39C-C4F7-F823-16E2-AFCA6020A3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99303A1-6B0E-6444-FE52-FC980AACD6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704EC9-29AF-394D-9BE9-383E8179A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F7D4F-61C6-82C7-C2CF-E6F524B2D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E77C6-858E-016C-293D-7F16693F9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093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84390-80E3-1176-AB94-73CE3BB5D6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F303F8-14C5-CFFA-A2F0-967EE11A21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9D9534-B68F-84DA-C50D-186555661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C258F2-8A31-F782-7DA2-24F4676FF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FFDB3-1DA9-22BC-B7C7-27F24EBDF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895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80AA20-54DB-EC23-074A-A6787C802A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9A8122-7EF8-D013-F437-B930B84E9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154C88-C2F7-B210-8AB8-D9DD2B304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D2190D-0B8D-1AA0-EE07-CE773F31C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278B85-1C66-1982-3A1D-8DC06A889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645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83427C-8D94-DE81-2CF9-308BBC6475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C07CD1-EA52-FBD7-AA22-79C6681812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F34BFC-6BD6-1600-9485-66645AD46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2FB1F1-AF50-8A00-2843-D8B19E8B1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7FB260-285E-239E-AE1A-7522688F4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542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A4501-B62F-D98D-A62A-17A8C9F605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3079E0-17FD-B2F0-0327-488F254576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E03D3B-47A8-FF39-B748-AED8C10D6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9D1512-7C6D-884B-5D8B-B01D24870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CB371F-4A1A-184B-58CB-4CAA428CE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644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72F6B8-B116-BB5C-D76C-B584D9E825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69D335-62F7-43E5-F9BB-F9F2E23910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1DC446-A8EB-AD64-FA40-674206D984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6D4F2A-EFBB-8A4E-69CD-CFB245DCF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AB9A7C-CCB3-8E57-1812-A859299F4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FF3A6D-E3DB-A861-D896-0CF7D7FC0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882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BA7B00-99A6-2256-2A21-639DB4976D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7D73FD-A6EC-E041-884E-60E158B95A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7F0C56-1016-AC27-6B9F-4FB2FA9D98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7C24F8-2717-EAC5-ED26-FC76790302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F6A728-3142-C632-6822-74F0055AFC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D42C4A-21BE-2AC1-881B-9E6C7A80A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36A2E6-A746-ED89-DF10-9980D76D4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B1C350-62B6-29E7-6DD9-6C136E019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62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B2C72B-B1BA-1FAF-F360-54FF88854B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BF24F6-495A-6B77-F0C3-ECF63881A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82276D-F9A6-9B43-23FF-EB5D5D5DE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0796CF-CD2C-EA68-25FA-EBDA995DE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811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7C0DD8-1B1A-A663-89C0-5CAF4FBB6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E6D699-1664-01E9-B9C5-C282BCF54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3AD712-B97C-ADDB-32A6-64F841772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76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D7E63A-AD17-8F9C-94C9-5C0A65A9C2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EAC136-8E65-2CBA-B2DB-96A71C630A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F965CB-B76B-E01E-8143-733BE9CCD1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0D3A6C-6EA4-E863-39D4-431265796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F3A811-5A7F-64E8-3BB9-5BA3863D2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23D584-85D7-F30C-17A4-D5F152D1B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61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583B07-CD0C-1003-1FE8-11BEFF2FD1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D4490D-6632-5786-3474-CE9A4FA0C7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CF9C8B-6D11-1075-7AE8-133E02A160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707564-C3DA-F815-5E9A-B2D3E7641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5F9494-1A4D-3D7A-4055-97D46D427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1E613D-5498-86B7-D29C-733ADD3B2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234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94127E-69E6-30DB-7FA6-73E9459C0F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834E40-0CE7-08DA-E906-1F11FD3350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8C5100-FCED-878B-3722-16641C91AC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54B206-6ED6-344B-8911-C55D402D86B1}" type="datetimeFigureOut">
              <a:rPr lang="en-US" smtClean="0"/>
              <a:t>9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1AC17C-48C6-022E-FDB8-46BE8ACB6E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58B75A-7AB9-B68F-85E7-E8B0321431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9E4A69-81FF-AB46-B785-94B8EC85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928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5" name="Group 124">
            <a:extLst>
              <a:ext uri="{FF2B5EF4-FFF2-40B4-BE49-F238E27FC236}">
                <a16:creationId xmlns:a16="http://schemas.microsoft.com/office/drawing/2014/main" id="{2B021726-FA11-0770-AAA5-0CEE6B8477AC}"/>
              </a:ext>
            </a:extLst>
          </p:cNvPr>
          <p:cNvGrpSpPr/>
          <p:nvPr/>
        </p:nvGrpSpPr>
        <p:grpSpPr>
          <a:xfrm>
            <a:off x="451747" y="925923"/>
            <a:ext cx="8534149" cy="3623802"/>
            <a:chOff x="451747" y="790842"/>
            <a:chExt cx="8534149" cy="3623802"/>
          </a:xfrm>
        </p:grpSpPr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2E2FAC00-84D9-77BA-ABBD-F43E1DB9C20A}"/>
                </a:ext>
              </a:extLst>
            </p:cNvPr>
            <p:cNvGrpSpPr/>
            <p:nvPr/>
          </p:nvGrpSpPr>
          <p:grpSpPr>
            <a:xfrm>
              <a:off x="451747" y="790842"/>
              <a:ext cx="5404767" cy="3615761"/>
              <a:chOff x="451747" y="790842"/>
              <a:chExt cx="5404767" cy="3615761"/>
            </a:xfrm>
          </p:grpSpPr>
          <p:pic>
            <p:nvPicPr>
              <p:cNvPr id="4" name="Picture 3" descr="A screenshot of a graph&#10;&#10;Description automatically generated">
                <a:extLst>
                  <a:ext uri="{FF2B5EF4-FFF2-40B4-BE49-F238E27FC236}">
                    <a16:creationId xmlns:a16="http://schemas.microsoft.com/office/drawing/2014/main" id="{2414CAE1-06D9-72D3-D840-EE6B408979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alphaModFix/>
              </a:blip>
              <a:srcRect l="20128" t="21806" r="51154" b="62799"/>
              <a:stretch/>
            </p:blipFill>
            <p:spPr>
              <a:xfrm>
                <a:off x="1535584" y="1030818"/>
                <a:ext cx="4230692" cy="1171894"/>
              </a:xfrm>
              <a:prstGeom prst="rect">
                <a:avLst/>
              </a:prstGeom>
            </p:spPr>
          </p:pic>
          <p:pic>
            <p:nvPicPr>
              <p:cNvPr id="5" name="Picture 4" descr="A screenshot of a graph&#10;&#10;Description automatically generated">
                <a:extLst>
                  <a:ext uri="{FF2B5EF4-FFF2-40B4-BE49-F238E27FC236}">
                    <a16:creationId xmlns:a16="http://schemas.microsoft.com/office/drawing/2014/main" id="{5EFCA9CD-A050-2DE2-852B-AF295ACFCE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alphaModFix/>
              </a:blip>
              <a:srcRect l="20128" t="57929" r="51154" b="22607"/>
              <a:stretch/>
            </p:blipFill>
            <p:spPr>
              <a:xfrm>
                <a:off x="1545357" y="2782965"/>
                <a:ext cx="4230692" cy="1481598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54747DA6-F7C6-CBB3-D4C1-DE6C613CB709}"/>
                  </a:ext>
                </a:extLst>
              </p:cNvPr>
              <p:cNvSpPr/>
              <p:nvPr/>
            </p:nvSpPr>
            <p:spPr>
              <a:xfrm>
                <a:off x="1362496" y="4318164"/>
                <a:ext cx="182867" cy="7171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241402B-9F7D-2E60-AEDF-7A9F5804DDB9}"/>
                  </a:ext>
                </a:extLst>
              </p:cNvPr>
              <p:cNvSpPr txBox="1"/>
              <p:nvPr/>
            </p:nvSpPr>
            <p:spPr>
              <a:xfrm>
                <a:off x="1932722" y="790842"/>
                <a:ext cx="6725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solidFill>
                      <a:schemeClr val="accent6"/>
                    </a:solidFill>
                  </a:rPr>
                  <a:t>Arousal</a:t>
                </a:r>
              </a:p>
            </p:txBody>
          </p:sp>
          <p:cxnSp>
            <p:nvCxnSpPr>
              <p:cNvPr id="11" name="Straight Arrow Connector 10">
                <a:extLst>
                  <a:ext uri="{FF2B5EF4-FFF2-40B4-BE49-F238E27FC236}">
                    <a16:creationId xmlns:a16="http://schemas.microsoft.com/office/drawing/2014/main" id="{FF0DED60-4DC0-2BA5-2980-909B52B9BF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86433" y="992839"/>
                <a:ext cx="28511" cy="200146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B4E48B7-F152-759A-5B2F-0F87A877A92F}"/>
                  </a:ext>
                </a:extLst>
              </p:cNvPr>
              <p:cNvSpPr txBox="1"/>
              <p:nvPr/>
            </p:nvSpPr>
            <p:spPr>
              <a:xfrm>
                <a:off x="609668" y="1575256"/>
                <a:ext cx="67163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Flow</a:t>
                </a:r>
              </a:p>
              <a:p>
                <a:pPr algn="ctr"/>
                <a:r>
                  <a:rPr lang="en-US" sz="1200" dirty="0"/>
                  <a:t>(L/min)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AB79BBB-0E54-222C-666C-9D469F9E40ED}"/>
                  </a:ext>
                </a:extLst>
              </p:cNvPr>
              <p:cNvSpPr txBox="1"/>
              <p:nvPr/>
            </p:nvSpPr>
            <p:spPr>
              <a:xfrm>
                <a:off x="1565341" y="2167431"/>
                <a:ext cx="11690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solidFill>
                      <a:srgbClr val="942092"/>
                    </a:solidFill>
                  </a:rPr>
                  <a:t>Obstructive Events</a:t>
                </a: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DAFEDF8F-B271-EE8C-811B-1C8AD53AB3CD}"/>
                  </a:ext>
                </a:extLst>
              </p:cNvPr>
              <p:cNvSpPr/>
              <p:nvPr/>
            </p:nvSpPr>
            <p:spPr>
              <a:xfrm>
                <a:off x="1335323" y="1285800"/>
                <a:ext cx="182867" cy="24236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8F305B38-5E35-F66A-2CBE-B4BCE15F5F43}"/>
                  </a:ext>
                </a:extLst>
              </p:cNvPr>
              <p:cNvSpPr txBox="1"/>
              <p:nvPr/>
            </p:nvSpPr>
            <p:spPr>
              <a:xfrm>
                <a:off x="451747" y="1083820"/>
                <a:ext cx="98747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EEG power </a:t>
                </a:r>
              </a:p>
              <a:p>
                <a:pPr algn="ctr"/>
                <a:r>
                  <a:rPr lang="en-US" sz="1200" dirty="0"/>
                  <a:t>(16-32Hz)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25401BDC-4F5D-4A5F-7780-6BEC3FE72A5B}"/>
                  </a:ext>
                </a:extLst>
              </p:cNvPr>
              <p:cNvSpPr txBox="1"/>
              <p:nvPr/>
            </p:nvSpPr>
            <p:spPr>
              <a:xfrm>
                <a:off x="1368421" y="4160382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0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BC1074C-32A9-77BA-3E97-136F62A0E09B}"/>
                  </a:ext>
                </a:extLst>
              </p:cNvPr>
              <p:cNvSpPr txBox="1"/>
              <p:nvPr/>
            </p:nvSpPr>
            <p:spPr>
              <a:xfrm>
                <a:off x="1272225" y="3855718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0.5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527DB3FC-16B4-BC22-6528-2549F5BD4AC6}"/>
                  </a:ext>
                </a:extLst>
              </p:cNvPr>
              <p:cNvSpPr txBox="1"/>
              <p:nvPr/>
            </p:nvSpPr>
            <p:spPr>
              <a:xfrm>
                <a:off x="1372022" y="3504814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C79CF1B2-0B42-9417-B1A3-CEBE47D33EEA}"/>
                  </a:ext>
                </a:extLst>
              </p:cNvPr>
              <p:cNvSpPr txBox="1"/>
              <p:nvPr/>
            </p:nvSpPr>
            <p:spPr>
              <a:xfrm>
                <a:off x="1272225" y="3190739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.5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3BD0DBB-CBD0-593F-65B3-5482AA90ED5D}"/>
                  </a:ext>
                </a:extLst>
              </p:cNvPr>
              <p:cNvSpPr txBox="1"/>
              <p:nvPr/>
            </p:nvSpPr>
            <p:spPr>
              <a:xfrm>
                <a:off x="1372022" y="2858250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2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5C34A38-11D3-946D-C908-1EF12075F37D}"/>
                  </a:ext>
                </a:extLst>
              </p:cNvPr>
              <p:cNvSpPr txBox="1"/>
              <p:nvPr/>
            </p:nvSpPr>
            <p:spPr>
              <a:xfrm>
                <a:off x="1263084" y="2536743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2.5</a:t>
                </a:r>
              </a:p>
            </p:txBody>
          </p: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id="{B8A21204-3967-03FC-8F8D-DAE3A3F6B2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35584" y="2626369"/>
                <a:ext cx="0" cy="166784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AA1FB20B-F6EF-5F6C-47D6-7A2208B86F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35584" y="1146197"/>
                <a:ext cx="0" cy="9601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097209A5-F5F2-9563-4EB9-21CAD5D429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24668" y="4292248"/>
                <a:ext cx="4331846" cy="2591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A10A0F2-890C-B4C5-9F29-3E603EC537F3}"/>
                  </a:ext>
                </a:extLst>
              </p:cNvPr>
              <p:cNvSpPr txBox="1"/>
              <p:nvPr/>
            </p:nvSpPr>
            <p:spPr>
              <a:xfrm>
                <a:off x="514391" y="3288326"/>
                <a:ext cx="86218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Ventilation (relative to Eupnea)</a:t>
                </a:r>
              </a:p>
            </p:txBody>
          </p:sp>
          <p:cxnSp>
            <p:nvCxnSpPr>
              <p:cNvPr id="43" name="Straight Arrow Connector 42">
                <a:extLst>
                  <a:ext uri="{FF2B5EF4-FFF2-40B4-BE49-F238E27FC236}">
                    <a16:creationId xmlns:a16="http://schemas.microsoft.com/office/drawing/2014/main" id="{EEC3A415-A0D4-CF32-06C8-54D205CF4E7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116625" y="1898394"/>
                <a:ext cx="22730" cy="329309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16F9D6A4-B681-9C77-6EDA-4232D9335501}"/>
                  </a:ext>
                </a:extLst>
              </p:cNvPr>
              <p:cNvSpPr txBox="1"/>
              <p:nvPr/>
            </p:nvSpPr>
            <p:spPr>
              <a:xfrm>
                <a:off x="1492615" y="2426168"/>
                <a:ext cx="79381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solidFill>
                      <a:srgbClr val="942092"/>
                    </a:solidFill>
                  </a:rPr>
                  <a:t>Observed Ventilation</a:t>
                </a:r>
              </a:p>
            </p:txBody>
          </p:sp>
          <p:cxnSp>
            <p:nvCxnSpPr>
              <p:cNvPr id="57" name="Straight Arrow Connector 56">
                <a:extLst>
                  <a:ext uri="{FF2B5EF4-FFF2-40B4-BE49-F238E27FC236}">
                    <a16:creationId xmlns:a16="http://schemas.microsoft.com/office/drawing/2014/main" id="{329A93FA-4580-523F-AA3D-51586D0D5C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71900" y="2814947"/>
                <a:ext cx="201420" cy="103273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15554EBB-228D-6123-0B0D-0346991375FD}"/>
                  </a:ext>
                </a:extLst>
              </p:cNvPr>
              <p:cNvSpPr txBox="1"/>
              <p:nvPr/>
            </p:nvSpPr>
            <p:spPr>
              <a:xfrm>
                <a:off x="2289284" y="2490424"/>
                <a:ext cx="105405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solidFill>
                      <a:schemeClr val="accent6"/>
                    </a:solidFill>
                  </a:rPr>
                  <a:t>Ventilatory</a:t>
                </a:r>
              </a:p>
              <a:p>
                <a:pPr algn="ctr"/>
                <a:r>
                  <a:rPr lang="en-US" sz="1000" dirty="0">
                    <a:solidFill>
                      <a:schemeClr val="accent6"/>
                    </a:solidFill>
                  </a:rPr>
                  <a:t>Drive (modeled)</a:t>
                </a:r>
              </a:p>
            </p:txBody>
          </p:sp>
          <p:cxnSp>
            <p:nvCxnSpPr>
              <p:cNvPr id="65" name="Straight Arrow Connector 64">
                <a:extLst>
                  <a:ext uri="{FF2B5EF4-FFF2-40B4-BE49-F238E27FC236}">
                    <a16:creationId xmlns:a16="http://schemas.microsoft.com/office/drawing/2014/main" id="{F003BBDB-6BA1-15AD-3204-33AFEEA5BE7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487765" y="2858250"/>
                <a:ext cx="235019" cy="291080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1B9B2DFE-8625-DA28-7467-8E68BB1AAF23}"/>
                  </a:ext>
                </a:extLst>
              </p:cNvPr>
              <p:cNvSpPr txBox="1"/>
              <p:nvPr/>
            </p:nvSpPr>
            <p:spPr>
              <a:xfrm>
                <a:off x="3074302" y="2488456"/>
                <a:ext cx="1054051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Chemical</a:t>
                </a:r>
              </a:p>
              <a:p>
                <a:pPr algn="ctr"/>
                <a:r>
                  <a:rPr lang="en-US" sz="1000" dirty="0"/>
                  <a:t>Drive</a:t>
                </a:r>
              </a:p>
              <a:p>
                <a:pPr algn="ctr"/>
                <a:r>
                  <a:rPr lang="en-US" sz="1000" dirty="0"/>
                  <a:t>(modeled)</a:t>
                </a:r>
              </a:p>
            </p:txBody>
          </p:sp>
          <p:cxnSp>
            <p:nvCxnSpPr>
              <p:cNvPr id="68" name="Straight Arrow Connector 67">
                <a:extLst>
                  <a:ext uri="{FF2B5EF4-FFF2-40B4-BE49-F238E27FC236}">
                    <a16:creationId xmlns:a16="http://schemas.microsoft.com/office/drawing/2014/main" id="{3B6765B3-01EC-F8CF-E6C2-A97E1D63314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72028" y="2950176"/>
                <a:ext cx="206600" cy="587429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5" name="Left Brace 74">
                <a:extLst>
                  <a:ext uri="{FF2B5EF4-FFF2-40B4-BE49-F238E27FC236}">
                    <a16:creationId xmlns:a16="http://schemas.microsoft.com/office/drawing/2014/main" id="{2C371E13-07C1-BBB3-A594-361E172874C3}"/>
                  </a:ext>
                </a:extLst>
              </p:cNvPr>
              <p:cNvSpPr/>
              <p:nvPr/>
            </p:nvSpPr>
            <p:spPr>
              <a:xfrm>
                <a:off x="3081080" y="3243451"/>
                <a:ext cx="45719" cy="152014"/>
              </a:xfrm>
              <a:prstGeom prst="lef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D1EB93B3-55F0-1520-26F3-100945BDB044}"/>
                  </a:ext>
                </a:extLst>
              </p:cNvPr>
              <p:cNvSpPr txBox="1"/>
              <p:nvPr/>
            </p:nvSpPr>
            <p:spPr>
              <a:xfrm>
                <a:off x="2757358" y="3198433"/>
                <a:ext cx="39946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/>
                  <a:t>VRA</a:t>
                </a:r>
              </a:p>
            </p:txBody>
          </p: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6603FBEC-F5C3-9078-0438-76F84413E0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1192" y="2073937"/>
                <a:ext cx="70601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0D04C415-A288-2CB8-FB46-C120F0EB3A60}"/>
                  </a:ext>
                </a:extLst>
              </p:cNvPr>
              <p:cNvSpPr txBox="1"/>
              <p:nvPr/>
            </p:nvSpPr>
            <p:spPr>
              <a:xfrm>
                <a:off x="2991866" y="2061592"/>
                <a:ext cx="76495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0 seconds</a:t>
                </a:r>
              </a:p>
            </p:txBody>
          </p:sp>
          <p:sp>
            <p:nvSpPr>
              <p:cNvPr id="81" name="Left Brace 80">
                <a:extLst>
                  <a:ext uri="{FF2B5EF4-FFF2-40B4-BE49-F238E27FC236}">
                    <a16:creationId xmlns:a16="http://schemas.microsoft.com/office/drawing/2014/main" id="{A60EA189-3EBF-55EC-98CC-86173E33F35F}"/>
                  </a:ext>
                </a:extLst>
              </p:cNvPr>
              <p:cNvSpPr/>
              <p:nvPr/>
            </p:nvSpPr>
            <p:spPr>
              <a:xfrm rot="5400000">
                <a:off x="3373756" y="3415043"/>
                <a:ext cx="66131" cy="65249"/>
              </a:xfrm>
              <a:prstGeom prst="leftBrac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6A32FF1F-740F-CF1C-B059-9118D3228638}"/>
                  </a:ext>
                </a:extLst>
              </p:cNvPr>
              <p:cNvSpPr txBox="1"/>
              <p:nvPr/>
            </p:nvSpPr>
            <p:spPr>
              <a:xfrm>
                <a:off x="3268175" y="3229461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/>
                  <a:t>Delay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9ABA4B8B-DD25-286F-54C3-7B4AA30B1A74}"/>
                  </a:ext>
                </a:extLst>
              </p:cNvPr>
              <p:cNvSpPr txBox="1"/>
              <p:nvPr/>
            </p:nvSpPr>
            <p:spPr>
              <a:xfrm>
                <a:off x="3889585" y="2187720"/>
                <a:ext cx="1154572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/>
                  <a:t>Ventilatory Drive prior to Arousal (Arousal Threshold)</a:t>
                </a:r>
              </a:p>
            </p:txBody>
          </p:sp>
          <p:cxnSp>
            <p:nvCxnSpPr>
              <p:cNvPr id="84" name="Straight Arrow Connector 83">
                <a:extLst>
                  <a:ext uri="{FF2B5EF4-FFF2-40B4-BE49-F238E27FC236}">
                    <a16:creationId xmlns:a16="http://schemas.microsoft.com/office/drawing/2014/main" id="{74E13D34-5F46-2D98-F341-EF47C837441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87882" y="2950176"/>
                <a:ext cx="464375" cy="587429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84C430DF-DD73-F299-55AC-FB642B704CDB}"/>
                </a:ext>
              </a:extLst>
            </p:cNvPr>
            <p:cNvGrpSpPr/>
            <p:nvPr/>
          </p:nvGrpSpPr>
          <p:grpSpPr>
            <a:xfrm>
              <a:off x="5917519" y="1109983"/>
              <a:ext cx="3068377" cy="3304661"/>
              <a:chOff x="6062375" y="1109983"/>
              <a:chExt cx="3068377" cy="3304661"/>
            </a:xfrm>
          </p:grpSpPr>
          <p:pic>
            <p:nvPicPr>
              <p:cNvPr id="9" name="Picture 8" descr="A group of red graphs&#10;&#10;Description automatically generated with medium confidence">
                <a:extLst>
                  <a:ext uri="{FF2B5EF4-FFF2-40B4-BE49-F238E27FC236}">
                    <a16:creationId xmlns:a16="http://schemas.microsoft.com/office/drawing/2014/main" id="{30DCAA3F-2437-560F-1C72-BF76D32991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2681" r="63948" b="10041"/>
              <a:stretch/>
            </p:blipFill>
            <p:spPr>
              <a:xfrm>
                <a:off x="6612594" y="1109983"/>
                <a:ext cx="2500811" cy="2625298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F5281BC7-AC7E-ADF1-F4B2-4B48468B8E04}"/>
                  </a:ext>
                </a:extLst>
              </p:cNvPr>
              <p:cNvSpPr txBox="1"/>
              <p:nvPr/>
            </p:nvSpPr>
            <p:spPr>
              <a:xfrm>
                <a:off x="6740090" y="3952979"/>
                <a:ext cx="223348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Ventilatory Drive, estimated (%eupnea)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20C76075-8D06-BA98-E587-66B3A7A49525}"/>
                  </a:ext>
                </a:extLst>
              </p:cNvPr>
              <p:cNvSpPr txBox="1"/>
              <p:nvPr/>
            </p:nvSpPr>
            <p:spPr>
              <a:xfrm rot="16200000">
                <a:off x="5084132" y="2336468"/>
                <a:ext cx="22334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Ventilation, observed (%eupnea)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67104BCD-8605-8D13-A6AD-670282506C88}"/>
                  </a:ext>
                </a:extLst>
              </p:cNvPr>
              <p:cNvSpPr txBox="1"/>
              <p:nvPr/>
            </p:nvSpPr>
            <p:spPr>
              <a:xfrm>
                <a:off x="7421035" y="3581662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0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67711AAB-AC7C-3250-932C-C70E750F0086}"/>
                  </a:ext>
                </a:extLst>
              </p:cNvPr>
              <p:cNvSpPr txBox="1"/>
              <p:nvPr/>
            </p:nvSpPr>
            <p:spPr>
              <a:xfrm>
                <a:off x="6345851" y="3003422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50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76FE99D2-F3D3-FA7F-98B5-7FB7B2915792}"/>
                  </a:ext>
                </a:extLst>
              </p:cNvPr>
              <p:cNvSpPr txBox="1"/>
              <p:nvPr/>
            </p:nvSpPr>
            <p:spPr>
              <a:xfrm>
                <a:off x="6280127" y="2432145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5A1AB3A8-4929-7B21-FB5B-FECE2C05673B}"/>
                  </a:ext>
                </a:extLst>
              </p:cNvPr>
              <p:cNvSpPr txBox="1"/>
              <p:nvPr/>
            </p:nvSpPr>
            <p:spPr>
              <a:xfrm>
                <a:off x="6280127" y="1858586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50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DB69814C-35D6-FC67-8FA0-9206A9D5BE7F}"/>
                  </a:ext>
                </a:extLst>
              </p:cNvPr>
              <p:cNvSpPr txBox="1"/>
              <p:nvPr/>
            </p:nvSpPr>
            <p:spPr>
              <a:xfrm>
                <a:off x="6280127" y="127712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200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1A257F71-CE39-0751-5AD0-317114601C06}"/>
                  </a:ext>
                </a:extLst>
              </p:cNvPr>
              <p:cNvSpPr txBox="1"/>
              <p:nvPr/>
            </p:nvSpPr>
            <p:spPr>
              <a:xfrm>
                <a:off x="7528038" y="3735281"/>
                <a:ext cx="25039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0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405CACBB-3A23-6301-2350-3BA429AD1F63}"/>
                  </a:ext>
                </a:extLst>
              </p:cNvPr>
              <p:cNvSpPr txBox="1"/>
              <p:nvPr/>
            </p:nvSpPr>
            <p:spPr>
              <a:xfrm>
                <a:off x="6879869" y="3735281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50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2C7DAADA-8226-889D-C856-19391763AD8A}"/>
                  </a:ext>
                </a:extLst>
              </p:cNvPr>
              <p:cNvSpPr txBox="1"/>
              <p:nvPr/>
            </p:nvSpPr>
            <p:spPr>
              <a:xfrm>
                <a:off x="7219882" y="373528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2E8A070C-3A35-FCE9-D573-DB855D49E1CB}"/>
                  </a:ext>
                </a:extLst>
              </p:cNvPr>
              <p:cNvSpPr txBox="1"/>
              <p:nvPr/>
            </p:nvSpPr>
            <p:spPr>
              <a:xfrm>
                <a:off x="7597534" y="373528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50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2BC3A388-D8E1-47E5-4E8B-4D75E056F908}"/>
                  </a:ext>
                </a:extLst>
              </p:cNvPr>
              <p:cNvSpPr txBox="1"/>
              <p:nvPr/>
            </p:nvSpPr>
            <p:spPr>
              <a:xfrm>
                <a:off x="7973042" y="373528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200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CED66308-40C8-E970-3432-65EBBBF9281D}"/>
                  </a:ext>
                </a:extLst>
              </p:cNvPr>
              <p:cNvSpPr txBox="1"/>
              <p:nvPr/>
            </p:nvSpPr>
            <p:spPr>
              <a:xfrm>
                <a:off x="8364539" y="373528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250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0117F437-B079-2E04-E932-A3DB91CAB9EE}"/>
                  </a:ext>
                </a:extLst>
              </p:cNvPr>
              <p:cNvSpPr txBox="1"/>
              <p:nvPr/>
            </p:nvSpPr>
            <p:spPr>
              <a:xfrm>
                <a:off x="8748916" y="373528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300</a:t>
                </a:r>
              </a:p>
            </p:txBody>
          </p:sp>
          <p:cxnSp>
            <p:nvCxnSpPr>
              <p:cNvPr id="108" name="Straight Arrow Connector 107">
                <a:extLst>
                  <a:ext uri="{FF2B5EF4-FFF2-40B4-BE49-F238E27FC236}">
                    <a16:creationId xmlns:a16="http://schemas.microsoft.com/office/drawing/2014/main" id="{BF569A9C-4036-EB70-3DD9-C24565024F0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753077" y="2643011"/>
                <a:ext cx="296050" cy="0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C8C1981E-5B0C-44A2-4D13-4612DA4DA8B9}"/>
                  </a:ext>
                </a:extLst>
              </p:cNvPr>
              <p:cNvSpPr txBox="1"/>
              <p:nvPr/>
            </p:nvSpPr>
            <p:spPr>
              <a:xfrm>
                <a:off x="7978938" y="2508223"/>
                <a:ext cx="56618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>
                    <a:solidFill>
                      <a:srgbClr val="C00000"/>
                    </a:solidFill>
                  </a:rPr>
                  <a:t>Vactive</a:t>
                </a:r>
                <a:endParaRPr lang="en-US" sz="1000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03B4F1D8-08B7-F622-72EF-0AC5ABEF3BB8}"/>
                  </a:ext>
                </a:extLst>
              </p:cNvPr>
              <p:cNvSpPr txBox="1"/>
              <p:nvPr/>
            </p:nvSpPr>
            <p:spPr>
              <a:xfrm>
                <a:off x="7995480" y="3019347"/>
                <a:ext cx="6351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>
                    <a:solidFill>
                      <a:srgbClr val="942092"/>
                    </a:solidFill>
                  </a:rPr>
                  <a:t>Vpassive</a:t>
                </a:r>
                <a:endParaRPr lang="en-US" sz="1000" dirty="0">
                  <a:solidFill>
                    <a:srgbClr val="942092"/>
                  </a:solidFill>
                </a:endParaRPr>
              </a:p>
            </p:txBody>
          </p:sp>
          <p:cxnSp>
            <p:nvCxnSpPr>
              <p:cNvPr id="112" name="Straight Arrow Connector 111">
                <a:extLst>
                  <a:ext uri="{FF2B5EF4-FFF2-40B4-BE49-F238E27FC236}">
                    <a16:creationId xmlns:a16="http://schemas.microsoft.com/office/drawing/2014/main" id="{6F1501E3-DE77-D528-6318-9F2B6EAC9C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454533" y="3149330"/>
                <a:ext cx="594594" cy="12889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52340718-ABDC-D0BD-B1A1-88D41836A496}"/>
                  </a:ext>
                </a:extLst>
              </p:cNvPr>
              <p:cNvSpPr txBox="1"/>
              <p:nvPr/>
            </p:nvSpPr>
            <p:spPr>
              <a:xfrm>
                <a:off x="7673315" y="3267300"/>
                <a:ext cx="4555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>
                    <a:solidFill>
                      <a:srgbClr val="942092"/>
                    </a:solidFill>
                  </a:rPr>
                  <a:t>Vmin</a:t>
                </a:r>
                <a:endParaRPr lang="en-US" sz="1000" dirty="0">
                  <a:solidFill>
                    <a:srgbClr val="942092"/>
                  </a:solidFill>
                </a:endParaRPr>
              </a:p>
            </p:txBody>
          </p:sp>
          <p:cxnSp>
            <p:nvCxnSpPr>
              <p:cNvPr id="115" name="Straight Arrow Connector 114">
                <a:extLst>
                  <a:ext uri="{FF2B5EF4-FFF2-40B4-BE49-F238E27FC236}">
                    <a16:creationId xmlns:a16="http://schemas.microsoft.com/office/drawing/2014/main" id="{7E905134-51C5-E7A1-8696-F1A9B6BB27A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272658" y="3254213"/>
                <a:ext cx="390808" cy="115659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E856F8D8-2528-FED2-8BAE-E0379E00D710}"/>
                  </a:ext>
                </a:extLst>
              </p:cNvPr>
              <p:cNvSpPr txBox="1"/>
              <p:nvPr/>
            </p:nvSpPr>
            <p:spPr>
              <a:xfrm>
                <a:off x="7929033" y="3483013"/>
                <a:ext cx="11256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chemeClr val="accent6"/>
                    </a:solidFill>
                  </a:rPr>
                  <a:t>Arousal Threshold</a:t>
                </a:r>
              </a:p>
            </p:txBody>
          </p:sp>
          <p:cxnSp>
            <p:nvCxnSpPr>
              <p:cNvPr id="119" name="Straight Arrow Connector 118">
                <a:extLst>
                  <a:ext uri="{FF2B5EF4-FFF2-40B4-BE49-F238E27FC236}">
                    <a16:creationId xmlns:a16="http://schemas.microsoft.com/office/drawing/2014/main" id="{50403FC8-B197-4080-05F0-80669469DBE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709645" y="3614175"/>
                <a:ext cx="257957" cy="8240"/>
              </a:xfrm>
              <a:prstGeom prst="straightConnector1">
                <a:avLst/>
              </a:prstGeom>
              <a:ln w="9525">
                <a:tailEnd type="triangle" w="sm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3" name="Oval 2">
            <a:extLst>
              <a:ext uri="{FF2B5EF4-FFF2-40B4-BE49-F238E27FC236}">
                <a16:creationId xmlns:a16="http://schemas.microsoft.com/office/drawing/2014/main" id="{7FEA28E7-4CE1-B0E1-630E-FD9EB282A319}"/>
              </a:ext>
            </a:extLst>
          </p:cNvPr>
          <p:cNvSpPr>
            <a:spLocks noChangeAspect="1"/>
          </p:cNvSpPr>
          <p:nvPr/>
        </p:nvSpPr>
        <p:spPr>
          <a:xfrm>
            <a:off x="7100592" y="3341675"/>
            <a:ext cx="58344" cy="61723"/>
          </a:xfrm>
          <a:prstGeom prst="ellips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643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3</TotalTime>
  <Words>82</Words>
  <Application>Microsoft Macintosh PowerPoint</Application>
  <PresentationFormat>Widescreen</PresentationFormat>
  <Paragraphs>4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kes, Brandon</dc:creator>
  <cp:lastModifiedBy>Nokes, Brandon</cp:lastModifiedBy>
  <cp:revision>8</cp:revision>
  <dcterms:created xsi:type="dcterms:W3CDTF">2024-02-27T21:33:23Z</dcterms:created>
  <dcterms:modified xsi:type="dcterms:W3CDTF">2025-09-05T14:06:01Z</dcterms:modified>
</cp:coreProperties>
</file>